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98" r:id="rId2"/>
  </p:sldIdLst>
  <p:sldSz cx="6492875" cy="6218238"/>
  <p:notesSz cx="7023100" cy="93091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437" userDrawn="1">
          <p15:clr>
            <a:srgbClr val="A4A3A4"/>
          </p15:clr>
        </p15:guide>
        <p15:guide id="3" orient="horz" pos="375" userDrawn="1">
          <p15:clr>
            <a:srgbClr val="A4A3A4"/>
          </p15:clr>
        </p15:guide>
        <p15:guide id="4" pos="1349" userDrawn="1">
          <p15:clr>
            <a:srgbClr val="A4A3A4"/>
          </p15:clr>
        </p15:guide>
        <p15:guide id="5" orient="horz" pos="203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audhary, Ritu" initials="CR" lastIdx="1" clrIdx="0">
    <p:extLst>
      <p:ext uri="{19B8F6BF-5375-455C-9EA6-DF929625EA0E}">
        <p15:presenceInfo xmlns:p15="http://schemas.microsoft.com/office/powerpoint/2012/main" userId="S::Ritu.Chaudhary@moffitt.org::e213b328-12f3-42f9-9afb-2fdf354946f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D0DF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132" autoAdjust="0"/>
    <p:restoredTop sz="90099" autoAdjust="0"/>
  </p:normalViewPr>
  <p:slideViewPr>
    <p:cSldViewPr snapToGrid="0">
      <p:cViewPr varScale="1">
        <p:scale>
          <a:sx n="160" d="100"/>
          <a:sy n="160" d="100"/>
        </p:scale>
        <p:origin x="3736" y="84"/>
      </p:cViewPr>
      <p:guideLst>
        <p:guide pos="3437"/>
        <p:guide orient="horz" pos="375"/>
        <p:guide pos="1349"/>
        <p:guide orient="horz" pos="203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3343" cy="467072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8132" y="0"/>
            <a:ext cx="3043343" cy="467072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r">
              <a:defRPr sz="1200"/>
            </a:lvl1pPr>
          </a:lstStyle>
          <a:p>
            <a:fld id="{E3D79D2C-534C-49B8-BF89-98F21FED85F5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871663" y="1163638"/>
            <a:ext cx="3279775" cy="31416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324" tIns="46662" rIns="93324" bIns="4666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2310" y="4480004"/>
            <a:ext cx="5618480" cy="3665458"/>
          </a:xfrm>
          <a:prstGeom prst="rect">
            <a:avLst/>
          </a:prstGeom>
        </p:spPr>
        <p:txBody>
          <a:bodyPr vert="horz" lIns="93324" tIns="46662" rIns="93324" bIns="46662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030"/>
            <a:ext cx="3043343" cy="467071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8132" y="8842030"/>
            <a:ext cx="3043343" cy="467071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r">
              <a:defRPr sz="1200"/>
            </a:lvl1pPr>
          </a:lstStyle>
          <a:p>
            <a:fld id="{3FBF2B51-D0C1-4CC3-B696-54FB44FD7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4849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1pPr>
    <a:lvl2pPr marL="22876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2pPr>
    <a:lvl3pPr marL="45752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3pPr>
    <a:lvl4pPr marL="68628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4pPr>
    <a:lvl5pPr marL="91504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5pPr>
    <a:lvl6pPr marL="1143799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6pPr>
    <a:lvl7pPr marL="1372559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7pPr>
    <a:lvl8pPr marL="1601319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8pPr>
    <a:lvl9pPr marL="1830079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FBF2B51-D0C1-4CC3-B696-54FB44FD7B1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7429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966" y="1017661"/>
            <a:ext cx="5518944" cy="2164868"/>
          </a:xfrm>
        </p:spPr>
        <p:txBody>
          <a:bodyPr anchor="b"/>
          <a:lstStyle>
            <a:lvl1pPr algn="ctr">
              <a:defRPr sz="42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1610" y="3266015"/>
            <a:ext cx="4869656" cy="1501301"/>
          </a:xfrm>
        </p:spPr>
        <p:txBody>
          <a:bodyPr/>
          <a:lstStyle>
            <a:lvl1pPr marL="0" indent="0" algn="ctr">
              <a:buNone/>
              <a:defRPr sz="1704"/>
            </a:lvl1pPr>
            <a:lvl2pPr marL="324658" indent="0" algn="ctr">
              <a:buNone/>
              <a:defRPr sz="1420"/>
            </a:lvl2pPr>
            <a:lvl3pPr marL="649315" indent="0" algn="ctr">
              <a:buNone/>
              <a:defRPr sz="1278"/>
            </a:lvl3pPr>
            <a:lvl4pPr marL="973973" indent="0" algn="ctr">
              <a:buNone/>
              <a:defRPr sz="1136"/>
            </a:lvl4pPr>
            <a:lvl5pPr marL="1298631" indent="0" algn="ctr">
              <a:buNone/>
              <a:defRPr sz="1136"/>
            </a:lvl5pPr>
            <a:lvl6pPr marL="1623289" indent="0" algn="ctr">
              <a:buNone/>
              <a:defRPr sz="1136"/>
            </a:lvl6pPr>
            <a:lvl7pPr marL="1947946" indent="0" algn="ctr">
              <a:buNone/>
              <a:defRPr sz="1136"/>
            </a:lvl7pPr>
            <a:lvl8pPr marL="2272604" indent="0" algn="ctr">
              <a:buNone/>
              <a:defRPr sz="1136"/>
            </a:lvl8pPr>
            <a:lvl9pPr marL="2597262" indent="0" algn="ctr">
              <a:buNone/>
              <a:defRPr sz="113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47527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628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46464" y="331064"/>
            <a:ext cx="1400026" cy="52696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6385" y="331064"/>
            <a:ext cx="4118918" cy="526966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9305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8610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3004" y="1550243"/>
            <a:ext cx="5600105" cy="2586614"/>
          </a:xfrm>
        </p:spPr>
        <p:txBody>
          <a:bodyPr anchor="b"/>
          <a:lstStyle>
            <a:lvl1pPr>
              <a:defRPr sz="42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3004" y="4161327"/>
            <a:ext cx="5600105" cy="1360239"/>
          </a:xfrm>
        </p:spPr>
        <p:txBody>
          <a:bodyPr/>
          <a:lstStyle>
            <a:lvl1pPr marL="0" indent="0">
              <a:buNone/>
              <a:defRPr sz="1704">
                <a:solidFill>
                  <a:schemeClr val="tx1"/>
                </a:solidFill>
              </a:defRPr>
            </a:lvl1pPr>
            <a:lvl2pPr marL="324658" indent="0">
              <a:buNone/>
              <a:defRPr sz="1420">
                <a:solidFill>
                  <a:schemeClr val="tx1">
                    <a:tint val="75000"/>
                  </a:schemeClr>
                </a:solidFill>
              </a:defRPr>
            </a:lvl2pPr>
            <a:lvl3pPr marL="649315" indent="0">
              <a:buNone/>
              <a:defRPr sz="1278">
                <a:solidFill>
                  <a:schemeClr val="tx1">
                    <a:tint val="75000"/>
                  </a:schemeClr>
                </a:solidFill>
              </a:defRPr>
            </a:lvl3pPr>
            <a:lvl4pPr marL="973973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4pPr>
            <a:lvl5pPr marL="1298631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5pPr>
            <a:lvl6pPr marL="1623289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6pPr>
            <a:lvl7pPr marL="1947946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7pPr>
            <a:lvl8pPr marL="2272604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8pPr>
            <a:lvl9pPr marL="2597262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5309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6385" y="1655318"/>
            <a:ext cx="2759472" cy="394541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7018" y="1655318"/>
            <a:ext cx="2759472" cy="394541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14088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331065"/>
            <a:ext cx="5600105" cy="12019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7232" y="1524332"/>
            <a:ext cx="2746790" cy="747052"/>
          </a:xfrm>
        </p:spPr>
        <p:txBody>
          <a:bodyPr anchor="b"/>
          <a:lstStyle>
            <a:lvl1pPr marL="0" indent="0">
              <a:buNone/>
              <a:defRPr sz="1704" b="1"/>
            </a:lvl1pPr>
            <a:lvl2pPr marL="324658" indent="0">
              <a:buNone/>
              <a:defRPr sz="1420" b="1"/>
            </a:lvl2pPr>
            <a:lvl3pPr marL="649315" indent="0">
              <a:buNone/>
              <a:defRPr sz="1278" b="1"/>
            </a:lvl3pPr>
            <a:lvl4pPr marL="973973" indent="0">
              <a:buNone/>
              <a:defRPr sz="1136" b="1"/>
            </a:lvl4pPr>
            <a:lvl5pPr marL="1298631" indent="0">
              <a:buNone/>
              <a:defRPr sz="1136" b="1"/>
            </a:lvl5pPr>
            <a:lvl6pPr marL="1623289" indent="0">
              <a:buNone/>
              <a:defRPr sz="1136" b="1"/>
            </a:lvl6pPr>
            <a:lvl7pPr marL="1947946" indent="0">
              <a:buNone/>
              <a:defRPr sz="1136" b="1"/>
            </a:lvl7pPr>
            <a:lvl8pPr marL="2272604" indent="0">
              <a:buNone/>
              <a:defRPr sz="1136" b="1"/>
            </a:lvl8pPr>
            <a:lvl9pPr marL="2597262" indent="0">
              <a:buNone/>
              <a:defRPr sz="11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7232" y="2271384"/>
            <a:ext cx="2746790" cy="334086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7018" y="1524332"/>
            <a:ext cx="2760318" cy="747052"/>
          </a:xfrm>
        </p:spPr>
        <p:txBody>
          <a:bodyPr anchor="b"/>
          <a:lstStyle>
            <a:lvl1pPr marL="0" indent="0">
              <a:buNone/>
              <a:defRPr sz="1704" b="1"/>
            </a:lvl1pPr>
            <a:lvl2pPr marL="324658" indent="0">
              <a:buNone/>
              <a:defRPr sz="1420" b="1"/>
            </a:lvl2pPr>
            <a:lvl3pPr marL="649315" indent="0">
              <a:buNone/>
              <a:defRPr sz="1278" b="1"/>
            </a:lvl3pPr>
            <a:lvl4pPr marL="973973" indent="0">
              <a:buNone/>
              <a:defRPr sz="1136" b="1"/>
            </a:lvl4pPr>
            <a:lvl5pPr marL="1298631" indent="0">
              <a:buNone/>
              <a:defRPr sz="1136" b="1"/>
            </a:lvl5pPr>
            <a:lvl6pPr marL="1623289" indent="0">
              <a:buNone/>
              <a:defRPr sz="1136" b="1"/>
            </a:lvl6pPr>
            <a:lvl7pPr marL="1947946" indent="0">
              <a:buNone/>
              <a:defRPr sz="1136" b="1"/>
            </a:lvl7pPr>
            <a:lvl8pPr marL="2272604" indent="0">
              <a:buNone/>
              <a:defRPr sz="1136" b="1"/>
            </a:lvl8pPr>
            <a:lvl9pPr marL="2597262" indent="0">
              <a:buNone/>
              <a:defRPr sz="11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7018" y="2271384"/>
            <a:ext cx="2760318" cy="334086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3870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6389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378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414549"/>
            <a:ext cx="2094121" cy="1450922"/>
          </a:xfrm>
        </p:spPr>
        <p:txBody>
          <a:bodyPr anchor="b"/>
          <a:lstStyle>
            <a:lvl1pPr>
              <a:defRPr sz="227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60318" y="895313"/>
            <a:ext cx="3287018" cy="4418979"/>
          </a:xfrm>
        </p:spPr>
        <p:txBody>
          <a:bodyPr/>
          <a:lstStyle>
            <a:lvl1pPr>
              <a:defRPr sz="2272"/>
            </a:lvl1pPr>
            <a:lvl2pPr>
              <a:defRPr sz="1988"/>
            </a:lvl2pPr>
            <a:lvl3pPr>
              <a:defRPr sz="1704"/>
            </a:lvl3pPr>
            <a:lvl4pPr>
              <a:defRPr sz="1420"/>
            </a:lvl4pPr>
            <a:lvl5pPr>
              <a:defRPr sz="1420"/>
            </a:lvl5pPr>
            <a:lvl6pPr>
              <a:defRPr sz="1420"/>
            </a:lvl6pPr>
            <a:lvl7pPr>
              <a:defRPr sz="1420"/>
            </a:lvl7pPr>
            <a:lvl8pPr>
              <a:defRPr sz="1420"/>
            </a:lvl8pPr>
            <a:lvl9pPr>
              <a:defRPr sz="142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231" y="1865471"/>
            <a:ext cx="2094121" cy="3456017"/>
          </a:xfrm>
        </p:spPr>
        <p:txBody>
          <a:bodyPr/>
          <a:lstStyle>
            <a:lvl1pPr marL="0" indent="0">
              <a:buNone/>
              <a:defRPr sz="1136"/>
            </a:lvl1pPr>
            <a:lvl2pPr marL="324658" indent="0">
              <a:buNone/>
              <a:defRPr sz="994"/>
            </a:lvl2pPr>
            <a:lvl3pPr marL="649315" indent="0">
              <a:buNone/>
              <a:defRPr sz="852"/>
            </a:lvl3pPr>
            <a:lvl4pPr marL="973973" indent="0">
              <a:buNone/>
              <a:defRPr sz="710"/>
            </a:lvl4pPr>
            <a:lvl5pPr marL="1298631" indent="0">
              <a:buNone/>
              <a:defRPr sz="710"/>
            </a:lvl5pPr>
            <a:lvl6pPr marL="1623289" indent="0">
              <a:buNone/>
              <a:defRPr sz="710"/>
            </a:lvl6pPr>
            <a:lvl7pPr marL="1947946" indent="0">
              <a:buNone/>
              <a:defRPr sz="710"/>
            </a:lvl7pPr>
            <a:lvl8pPr marL="2272604" indent="0">
              <a:buNone/>
              <a:defRPr sz="710"/>
            </a:lvl8pPr>
            <a:lvl9pPr marL="2597262" indent="0">
              <a:buNone/>
              <a:defRPr sz="7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80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414549"/>
            <a:ext cx="2094121" cy="1450922"/>
          </a:xfrm>
        </p:spPr>
        <p:txBody>
          <a:bodyPr anchor="b"/>
          <a:lstStyle>
            <a:lvl1pPr>
              <a:defRPr sz="227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60318" y="895313"/>
            <a:ext cx="3287018" cy="4418979"/>
          </a:xfrm>
        </p:spPr>
        <p:txBody>
          <a:bodyPr anchor="t"/>
          <a:lstStyle>
            <a:lvl1pPr marL="0" indent="0">
              <a:buNone/>
              <a:defRPr sz="2272"/>
            </a:lvl1pPr>
            <a:lvl2pPr marL="324658" indent="0">
              <a:buNone/>
              <a:defRPr sz="1988"/>
            </a:lvl2pPr>
            <a:lvl3pPr marL="649315" indent="0">
              <a:buNone/>
              <a:defRPr sz="1704"/>
            </a:lvl3pPr>
            <a:lvl4pPr marL="973973" indent="0">
              <a:buNone/>
              <a:defRPr sz="1420"/>
            </a:lvl4pPr>
            <a:lvl5pPr marL="1298631" indent="0">
              <a:buNone/>
              <a:defRPr sz="1420"/>
            </a:lvl5pPr>
            <a:lvl6pPr marL="1623289" indent="0">
              <a:buNone/>
              <a:defRPr sz="1420"/>
            </a:lvl6pPr>
            <a:lvl7pPr marL="1947946" indent="0">
              <a:buNone/>
              <a:defRPr sz="1420"/>
            </a:lvl7pPr>
            <a:lvl8pPr marL="2272604" indent="0">
              <a:buNone/>
              <a:defRPr sz="1420"/>
            </a:lvl8pPr>
            <a:lvl9pPr marL="2597262" indent="0">
              <a:buNone/>
              <a:defRPr sz="142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231" y="1865471"/>
            <a:ext cx="2094121" cy="3456017"/>
          </a:xfrm>
        </p:spPr>
        <p:txBody>
          <a:bodyPr/>
          <a:lstStyle>
            <a:lvl1pPr marL="0" indent="0">
              <a:buNone/>
              <a:defRPr sz="1136"/>
            </a:lvl1pPr>
            <a:lvl2pPr marL="324658" indent="0">
              <a:buNone/>
              <a:defRPr sz="994"/>
            </a:lvl2pPr>
            <a:lvl3pPr marL="649315" indent="0">
              <a:buNone/>
              <a:defRPr sz="852"/>
            </a:lvl3pPr>
            <a:lvl4pPr marL="973973" indent="0">
              <a:buNone/>
              <a:defRPr sz="710"/>
            </a:lvl4pPr>
            <a:lvl5pPr marL="1298631" indent="0">
              <a:buNone/>
              <a:defRPr sz="710"/>
            </a:lvl5pPr>
            <a:lvl6pPr marL="1623289" indent="0">
              <a:buNone/>
              <a:defRPr sz="710"/>
            </a:lvl6pPr>
            <a:lvl7pPr marL="1947946" indent="0">
              <a:buNone/>
              <a:defRPr sz="710"/>
            </a:lvl7pPr>
            <a:lvl8pPr marL="2272604" indent="0">
              <a:buNone/>
              <a:defRPr sz="710"/>
            </a:lvl8pPr>
            <a:lvl9pPr marL="2597262" indent="0">
              <a:buNone/>
              <a:defRPr sz="7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90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6385" y="331065"/>
            <a:ext cx="5600105" cy="12019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85" y="1655318"/>
            <a:ext cx="5600105" cy="394541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6385" y="5763387"/>
            <a:ext cx="1460897" cy="331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50765" y="5763387"/>
            <a:ext cx="2191345" cy="331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5593" y="5763387"/>
            <a:ext cx="1460897" cy="331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2525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49315" rtl="0" eaLnBrk="1" latinLnBrk="0" hangingPunct="1">
        <a:lnSpc>
          <a:spcPct val="90000"/>
        </a:lnSpc>
        <a:spcBef>
          <a:spcPct val="0"/>
        </a:spcBef>
        <a:buNone/>
        <a:defRPr sz="312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329" indent="-162329" algn="l" defTabSz="649315" rtl="0" eaLnBrk="1" latinLnBrk="0" hangingPunct="1">
        <a:lnSpc>
          <a:spcPct val="90000"/>
        </a:lnSpc>
        <a:spcBef>
          <a:spcPts val="710"/>
        </a:spcBef>
        <a:buFont typeface="Arial" panose="020B0604020202020204" pitchFamily="34" charset="0"/>
        <a:buChar char="•"/>
        <a:defRPr sz="1988" kern="1200">
          <a:solidFill>
            <a:schemeClr val="tx1"/>
          </a:solidFill>
          <a:latin typeface="+mn-lt"/>
          <a:ea typeface="+mn-ea"/>
          <a:cs typeface="+mn-cs"/>
        </a:defRPr>
      </a:lvl1pPr>
      <a:lvl2pPr marL="486987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704" kern="1200">
          <a:solidFill>
            <a:schemeClr val="tx1"/>
          </a:solidFill>
          <a:latin typeface="+mn-lt"/>
          <a:ea typeface="+mn-ea"/>
          <a:cs typeface="+mn-cs"/>
        </a:defRPr>
      </a:lvl2pPr>
      <a:lvl3pPr marL="811644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420" kern="1200">
          <a:solidFill>
            <a:schemeClr val="tx1"/>
          </a:solidFill>
          <a:latin typeface="+mn-lt"/>
          <a:ea typeface="+mn-ea"/>
          <a:cs typeface="+mn-cs"/>
        </a:defRPr>
      </a:lvl3pPr>
      <a:lvl4pPr marL="1136302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460960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785617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2110275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434933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759591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1pPr>
      <a:lvl2pPr marL="324658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2pPr>
      <a:lvl3pPr marL="649315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3pPr>
      <a:lvl4pPr marL="973973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298631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623289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1947946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272604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597262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0519A8C2-9960-4B6F-8196-C468A68C6C4C}"/>
              </a:ext>
            </a:extLst>
          </p:cNvPr>
          <p:cNvSpPr txBox="1"/>
          <p:nvPr/>
        </p:nvSpPr>
        <p:spPr>
          <a:xfrm>
            <a:off x="-32559" y="83860"/>
            <a:ext cx="3299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000" dirty="0"/>
              <a:t>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1804259-657A-4581-B145-807880ED9063}"/>
              </a:ext>
            </a:extLst>
          </p:cNvPr>
          <p:cNvSpPr txBox="1"/>
          <p:nvPr/>
        </p:nvSpPr>
        <p:spPr>
          <a:xfrm>
            <a:off x="3834897" y="343938"/>
            <a:ext cx="11286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mmun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CEBB641-3DCC-43AC-B19C-AF59B2BDD696}"/>
              </a:ext>
            </a:extLst>
          </p:cNvPr>
          <p:cNvSpPr txBox="1"/>
          <p:nvPr/>
        </p:nvSpPr>
        <p:spPr>
          <a:xfrm>
            <a:off x="2064445" y="343938"/>
            <a:ext cx="11286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ixture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8D39E71-D7AE-4002-8312-C9772E22BD4F}"/>
              </a:ext>
            </a:extLst>
          </p:cNvPr>
          <p:cNvSpPr txBox="1"/>
          <p:nvPr/>
        </p:nvSpPr>
        <p:spPr>
          <a:xfrm>
            <a:off x="446890" y="343938"/>
            <a:ext cx="11286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ypoxia</a:t>
            </a:r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4A248E69-F5D7-4AD4-9093-03F64890D772}"/>
              </a:ext>
            </a:extLst>
          </p:cNvPr>
          <p:cNvSpPr/>
          <p:nvPr/>
        </p:nvSpPr>
        <p:spPr>
          <a:xfrm>
            <a:off x="5368992" y="911256"/>
            <a:ext cx="69198" cy="68078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EC6BBECB-35FB-44B4-939F-BEC46A9FA1D0}"/>
              </a:ext>
            </a:extLst>
          </p:cNvPr>
          <p:cNvSpPr/>
          <p:nvPr/>
        </p:nvSpPr>
        <p:spPr>
          <a:xfrm>
            <a:off x="5368992" y="1070529"/>
            <a:ext cx="69198" cy="68078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DF203221-9FA6-4CD2-8D0F-F459924CB55D}"/>
              </a:ext>
            </a:extLst>
          </p:cNvPr>
          <p:cNvSpPr/>
          <p:nvPr/>
        </p:nvSpPr>
        <p:spPr>
          <a:xfrm>
            <a:off x="5368992" y="1227995"/>
            <a:ext cx="69198" cy="68078"/>
          </a:xfrm>
          <a:prstGeom prst="ellipse">
            <a:avLst/>
          </a:prstGeom>
          <a:solidFill>
            <a:srgbClr val="0D0DF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5BA1AA2-A637-4523-9D39-61B3EA971029}"/>
              </a:ext>
            </a:extLst>
          </p:cNvPr>
          <p:cNvSpPr txBox="1"/>
          <p:nvPr/>
        </p:nvSpPr>
        <p:spPr>
          <a:xfrm>
            <a:off x="5374523" y="829879"/>
            <a:ext cx="6370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ypoxi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EE762A0-F73D-49F6-B716-8AB64D141A97}"/>
              </a:ext>
            </a:extLst>
          </p:cNvPr>
          <p:cNvSpPr txBox="1"/>
          <p:nvPr/>
        </p:nvSpPr>
        <p:spPr>
          <a:xfrm>
            <a:off x="5374523" y="1146618"/>
            <a:ext cx="6370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mmune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C0D1A8D-42D9-46F3-997C-8BC4A524775F}"/>
              </a:ext>
            </a:extLst>
          </p:cNvPr>
          <p:cNvSpPr txBox="1"/>
          <p:nvPr/>
        </p:nvSpPr>
        <p:spPr>
          <a:xfrm>
            <a:off x="5374523" y="991047"/>
            <a:ext cx="6370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ixtur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CBBA44B-83C1-4B9F-90EA-7EEA951BE937}"/>
              </a:ext>
            </a:extLst>
          </p:cNvPr>
          <p:cNvSpPr txBox="1"/>
          <p:nvPr/>
        </p:nvSpPr>
        <p:spPr>
          <a:xfrm>
            <a:off x="4964707" y="-6680"/>
            <a:ext cx="1609950" cy="2484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137AF5DE-75FC-4C02-A64F-1F6B87B9B6E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32559" y="404420"/>
            <a:ext cx="1751192" cy="215664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74F57F0-C440-48B3-AD87-C7CB7941687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93261" y="390403"/>
            <a:ext cx="1782311" cy="2194964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775451E-63A9-47B5-AA14-0C124113D99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12246" y="381611"/>
            <a:ext cx="1798595" cy="221501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0229F46-3362-433F-A863-545DD8801CF5}"/>
              </a:ext>
            </a:extLst>
          </p:cNvPr>
          <p:cNvSpPr txBox="1"/>
          <p:nvPr/>
        </p:nvSpPr>
        <p:spPr>
          <a:xfrm>
            <a:off x="720969" y="3305908"/>
            <a:ext cx="5099539" cy="11182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6: 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IMEx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scores for the Immune gene signature among the 15 patients classified into the Hypoxia, Mixture and Immune subgroups.</a:t>
            </a:r>
            <a:r>
              <a:rPr lang="en-US" sz="1200" b="1" cap="all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80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3477485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715</TotalTime>
  <Words>37</Words>
  <Application>Microsoft Office PowerPoint</Application>
  <PresentationFormat>Custom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udhary, Ritu</dc:creator>
  <cp:lastModifiedBy>Chung, Christine H</cp:lastModifiedBy>
  <cp:revision>383</cp:revision>
  <cp:lastPrinted>2022-01-03T15:25:01Z</cp:lastPrinted>
  <dcterms:created xsi:type="dcterms:W3CDTF">2021-01-11T21:01:01Z</dcterms:created>
  <dcterms:modified xsi:type="dcterms:W3CDTF">2023-04-30T13:06:38Z</dcterms:modified>
</cp:coreProperties>
</file>